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12192000" cy="6858000"/>
  <p:notesSz cx="6858000" cy="994727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-102" y="-6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9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9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0CB566-3B20-4154-A778-75285434B7EA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44500" y="1243013"/>
            <a:ext cx="5969000" cy="33575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787126"/>
            <a:ext cx="5486400" cy="391674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48185"/>
            <a:ext cx="2971800" cy="499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9448185"/>
            <a:ext cx="2971800" cy="499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726D09-22FA-4882-9C88-E540C433E56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2650077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87851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116594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31900090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609600" y="274639"/>
            <a:ext cx="10972800" cy="585152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xmlns="" id="{D07C8E89-CA08-4FDD-8243-ECECF9EF71B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xmlns="" id="{99433B9F-20B7-40EF-9D0F-B082E5CF0F91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xmlns="" id="{3600D71F-D712-4988-8D6B-C3A8465A30C4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E1A33DB-13CC-4D99-8BCC-34AE9FC60BA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xmlns="" val="2179209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00248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187311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399282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63541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689847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9943181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22527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191661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454135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580448415"/>
              </p:ext>
            </p:extLst>
          </p:nvPr>
        </p:nvGraphicFramePr>
        <p:xfrm>
          <a:off x="1331844" y="417393"/>
          <a:ext cx="9621078" cy="6331287"/>
        </p:xfrm>
        <a:graphic>
          <a:graphicData uri="http://schemas.openxmlformats.org/drawingml/2006/table">
            <a:tbl>
              <a:tblPr/>
              <a:tblGrid>
                <a:gridCol w="1556481">
                  <a:extLst>
                    <a:ext uri="{9D8B030D-6E8A-4147-A177-3AD203B41FA5}">
                      <a16:colId xmlns:a16="http://schemas.microsoft.com/office/drawing/2014/main" xmlns="" val="3245188003"/>
                    </a:ext>
                  </a:extLst>
                </a:gridCol>
                <a:gridCol w="980046">
                  <a:extLst>
                    <a:ext uri="{9D8B030D-6E8A-4147-A177-3AD203B41FA5}">
                      <a16:colId xmlns:a16="http://schemas.microsoft.com/office/drawing/2014/main" xmlns="" val="1964972501"/>
                    </a:ext>
                  </a:extLst>
                </a:gridCol>
                <a:gridCol w="862656">
                  <a:extLst>
                    <a:ext uri="{9D8B030D-6E8A-4147-A177-3AD203B41FA5}">
                      <a16:colId xmlns:a16="http://schemas.microsoft.com/office/drawing/2014/main" xmlns="" val="967082307"/>
                    </a:ext>
                  </a:extLst>
                </a:gridCol>
                <a:gridCol w="815008">
                  <a:extLst>
                    <a:ext uri="{9D8B030D-6E8A-4147-A177-3AD203B41FA5}">
                      <a16:colId xmlns:a16="http://schemas.microsoft.com/office/drawing/2014/main" xmlns="" val="1479589848"/>
                    </a:ext>
                  </a:extLst>
                </a:gridCol>
                <a:gridCol w="904461">
                  <a:extLst>
                    <a:ext uri="{9D8B030D-6E8A-4147-A177-3AD203B41FA5}">
                      <a16:colId xmlns:a16="http://schemas.microsoft.com/office/drawing/2014/main" xmlns="" val="3611123062"/>
                    </a:ext>
                  </a:extLst>
                </a:gridCol>
                <a:gridCol w="526774">
                  <a:extLst>
                    <a:ext uri="{9D8B030D-6E8A-4147-A177-3AD203B41FA5}">
                      <a16:colId xmlns:a16="http://schemas.microsoft.com/office/drawing/2014/main" xmlns="" val="1426354676"/>
                    </a:ext>
                  </a:extLst>
                </a:gridCol>
                <a:gridCol w="3975652">
                  <a:extLst>
                    <a:ext uri="{9D8B030D-6E8A-4147-A177-3AD203B41FA5}">
                      <a16:colId xmlns:a16="http://schemas.microsoft.com/office/drawing/2014/main" xmlns="" val="3762830382"/>
                    </a:ext>
                  </a:extLst>
                </a:gridCol>
              </a:tblGrid>
              <a:tr h="22367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ccession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</a:t>
                      </a:r>
                      <a:r>
                        <a:rPr lang="en-US" sz="12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17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g2 ratio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value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DR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escription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09008770"/>
                  </a:ext>
                </a:extLst>
              </a:tr>
              <a:tr h="2020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6g46799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77.9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948.4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3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2555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eroxidase precursor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12486486"/>
                  </a:ext>
                </a:extLst>
              </a:tr>
              <a:tr h="2020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1g7317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874.6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696.5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04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935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eroxidase precursor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91415645"/>
                  </a:ext>
                </a:extLst>
              </a:tr>
              <a:tr h="2020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9g2354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9.8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80.3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01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144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ehydrogenase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68780446"/>
                  </a:ext>
                </a:extLst>
              </a:tr>
              <a:tr h="2020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1g2237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264.9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431.1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84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1233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eroxidase precursor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28876984"/>
                  </a:ext>
                </a:extLst>
              </a:tr>
              <a:tr h="2401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2g41630.2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3416.3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88896.9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66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24464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henylalanine ammonia-lyase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43417794"/>
                  </a:ext>
                </a:extLst>
              </a:tr>
              <a:tr h="2020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5g0438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441.7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175.3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5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624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eroxidase precursor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16748657"/>
                  </a:ext>
                </a:extLst>
              </a:tr>
              <a:tr h="2182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2g0810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586.1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4212.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5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177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MP-binding domain containing protein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39573838"/>
                  </a:ext>
                </a:extLst>
              </a:tr>
              <a:tr h="2020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5g0450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870.6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576.6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45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13469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eroxidase precursor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74625894"/>
                  </a:ext>
                </a:extLst>
              </a:tr>
              <a:tr h="1836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4g4376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1134.4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5550.1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29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39178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henylalanine ammonia-lyase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21907069"/>
                  </a:ext>
                </a:extLst>
              </a:tr>
              <a:tr h="2020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3g3205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84.1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267.6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1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41046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eroxidase precursor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15834366"/>
                  </a:ext>
                </a:extLst>
              </a:tr>
              <a:tr h="2020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2g0949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410.6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892.9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1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21567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ehydrogenase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86686154"/>
                  </a:ext>
                </a:extLst>
              </a:tr>
              <a:tr h="2020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10g36848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2.5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80.0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88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23532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ytochrome P450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98634877"/>
                  </a:ext>
                </a:extLst>
              </a:tr>
              <a:tr h="2020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9g2355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194.1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874.1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84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7988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ehydrogenase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11534296"/>
                  </a:ext>
                </a:extLst>
              </a:tr>
              <a:tr h="2020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9g2515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43.2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21.3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81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3635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innamoyl-CoA reductase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72036596"/>
                  </a:ext>
                </a:extLst>
              </a:tr>
              <a:tr h="2020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4g5915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650.7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8280.8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78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4578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eroxidase precursor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84496602"/>
                  </a:ext>
                </a:extLst>
              </a:tr>
              <a:tr h="2020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5g2564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671.5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826.8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69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146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ytochrome P450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45305270"/>
                  </a:ext>
                </a:extLst>
              </a:tr>
              <a:tr h="2020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5g4144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911.7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200.8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6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22612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ytochrome P450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91579002"/>
                  </a:ext>
                </a:extLst>
              </a:tr>
              <a:tr h="2333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6g4462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884.3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128.3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66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16478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MP-binding domain containing protein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65858015"/>
                  </a:ext>
                </a:extLst>
              </a:tr>
              <a:tr h="2020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2g1416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182.5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5189.2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65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22797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eroxidase precursor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52968997"/>
                  </a:ext>
                </a:extLst>
              </a:tr>
              <a:tr h="36328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1g7052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05.9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37.8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64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2448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2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Os1bglu5 - beta-glucosidase homologue, similar to G. max isohydroxyurate hydrolas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11880541"/>
                  </a:ext>
                </a:extLst>
              </a:tr>
              <a:tr h="1836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2g41650.3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098.8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410.0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62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17682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henylalanine ammonia-lyase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8216070"/>
                  </a:ext>
                </a:extLst>
              </a:tr>
              <a:tr h="2020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1g22336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814.9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877.1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59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664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eroxidase precursor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77720497"/>
                  </a:ext>
                </a:extLst>
              </a:tr>
              <a:tr h="1836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6g0698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809.9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282.4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58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25924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ffeoyl-CoA O-methyltransferase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81704564"/>
                  </a:ext>
                </a:extLst>
              </a:tr>
              <a:tr h="2020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2g1417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561.0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413.8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55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7322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eroxidase precursor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33853201"/>
                  </a:ext>
                </a:extLst>
              </a:tr>
              <a:tr h="2020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10g02040.2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7688.1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1725.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5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185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eroxidase precursor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14706470"/>
                  </a:ext>
                </a:extLst>
              </a:tr>
              <a:tr h="25744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7g4628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018.4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23.7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61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8858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Os7bglu26 -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eta-mannosidase/glucosidase/</a:t>
                      </a:r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exoglucana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0691428"/>
                  </a:ext>
                </a:extLst>
              </a:tr>
              <a:tr h="1836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3g4960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296.9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471.4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58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1148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Os3bglu7 - beta-glucosidase,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exo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beta-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lucans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,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83863547"/>
                  </a:ext>
                </a:extLst>
              </a:tr>
              <a:tr h="2020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4g5618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55.8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730.7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54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2499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eroxidase precursor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41461972"/>
                  </a:ext>
                </a:extLst>
              </a:tr>
              <a:tr h="2020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OC_Os01g36240.1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966.9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189.27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53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4456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eroxidase precursor, putative, expressed</a:t>
                      </a:r>
                    </a:p>
                  </a:txBody>
                  <a:tcPr marL="4121" marR="4121" marT="41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93554239"/>
                  </a:ext>
                </a:extLst>
              </a:tr>
            </a:tbl>
          </a:graphicData>
        </a:graphic>
      </p:graphicFrame>
      <p:sp>
        <p:nvSpPr>
          <p:cNvPr id="4" name="矩形 3"/>
          <p:cNvSpPr/>
          <p:nvPr/>
        </p:nvSpPr>
        <p:spPr>
          <a:xfrm>
            <a:off x="318052" y="96079"/>
            <a:ext cx="1133060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kern="0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altLang="zh-CN" sz="1400" b="1" kern="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1.5-fold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lterations of proteins involved in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phenylpropanoid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biosynthesis in comparison of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fc17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iTRAQ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data to that of the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9006253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35</TotalTime>
  <Words>382</Words>
  <Application>Microsoft Office PowerPoint</Application>
  <PresentationFormat>Custom</PresentationFormat>
  <Paragraphs>2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0012761</cp:lastModifiedBy>
  <cp:revision>97</cp:revision>
  <cp:lastPrinted>2018-10-21T01:09:07Z</cp:lastPrinted>
  <dcterms:created xsi:type="dcterms:W3CDTF">2018-01-28T13:46:17Z</dcterms:created>
  <dcterms:modified xsi:type="dcterms:W3CDTF">2018-10-27T12:46:22Z</dcterms:modified>
</cp:coreProperties>
</file>